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9" r:id="rId3"/>
    <p:sldId id="258" r:id="rId4"/>
    <p:sldId id="260" r:id="rId5"/>
    <p:sldId id="263" r:id="rId6"/>
    <p:sldId id="264" r:id="rId7"/>
    <p:sldId id="262" r:id="rId8"/>
    <p:sldId id="261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45"/>
    <p:restoredTop sz="94648"/>
  </p:normalViewPr>
  <p:slideViewPr>
    <p:cSldViewPr snapToGrid="0">
      <p:cViewPr varScale="1">
        <p:scale>
          <a:sx n="93" d="100"/>
          <a:sy n="93" d="100"/>
        </p:scale>
        <p:origin x="307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71A3990-8235-0F2A-A548-C865AD27465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EBFDF50F-015E-AC99-CBE5-734A3E2C1BA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3E219B7-57CF-8FDD-04C0-CA62E368C1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165C6-C8CD-4048-8DF5-28BD54BD31AA}" type="datetimeFigureOut">
              <a:rPr kumimoji="1" lang="zh-CN" altLang="en-US" smtClean="0"/>
              <a:t>2025/11/3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5AA2BF5-EDBE-C22B-483B-2A1552788B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908A5BF-2845-77EE-F7E5-6D31E8B304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1DF9A-5983-EE41-B6BA-93DBFD97DF6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30062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5033C50-51F3-2AB4-4D30-1B98481705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6DAC151-9160-D36D-0626-7CB7BF35D1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1763387-ACCC-DEA9-2A3C-076F65542E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165C6-C8CD-4048-8DF5-28BD54BD31AA}" type="datetimeFigureOut">
              <a:rPr kumimoji="1" lang="zh-CN" altLang="en-US" smtClean="0"/>
              <a:t>2025/11/3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2431211-41C3-2FE4-E534-7D940C3E44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056E68F-CA02-BE55-E000-CADB82E663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1DF9A-5983-EE41-B6BA-93DBFD97DF6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1333743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905A0E8-4AA6-380D-7214-8E22F6239EB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F5EE0C4-E245-4ECF-2CFC-DBD55A2FEE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C623E37-1E86-513C-2FE7-26C38AA2F4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165C6-C8CD-4048-8DF5-28BD54BD31AA}" type="datetimeFigureOut">
              <a:rPr kumimoji="1" lang="zh-CN" altLang="en-US" smtClean="0"/>
              <a:t>2025/11/3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B6361C0-587F-D5F1-8D12-9FBCECEEBE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1238378-F564-1A37-A6A5-246AF585C3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1DF9A-5983-EE41-B6BA-93DBFD97DF6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446984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7F5BECA-459B-7508-7076-64134CE16A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82EB501-FCE3-43B6-A92E-79053F5EDEA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E47AEF0-25DB-770E-53DA-93A61011F4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165C6-C8CD-4048-8DF5-28BD54BD31AA}" type="datetimeFigureOut">
              <a:rPr kumimoji="1" lang="zh-CN" altLang="en-US" smtClean="0"/>
              <a:t>2025/11/3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0F2CBF9-1824-A90E-31F8-99A7A9541D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3992681-8175-776D-6392-0646EA72B1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1DF9A-5983-EE41-B6BA-93DBFD97DF6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885375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023FED7-FC4A-F720-E3FF-E94759C413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D22BECF-3312-EE18-8D40-9F63BB2DC5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6458509-0CF5-307A-2B4A-0F7FEE8F78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165C6-C8CD-4048-8DF5-28BD54BD31AA}" type="datetimeFigureOut">
              <a:rPr kumimoji="1" lang="zh-CN" altLang="en-US" smtClean="0"/>
              <a:t>2025/11/3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A678D6E-8799-4666-8049-4636E8D851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4FF2F23-90D0-4BF0-3D54-90D411D3D4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1DF9A-5983-EE41-B6BA-93DBFD97DF6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580730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E66DBA1-5C33-B75F-2B7B-AC9FBE9EA7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CD008AF-8C2C-A9B5-FBE6-0561CD50E68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34EAB61-3757-BB4C-1818-CAB2CC1976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7F8A01C-607A-5852-96A2-2575AE649B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165C6-C8CD-4048-8DF5-28BD54BD31AA}" type="datetimeFigureOut">
              <a:rPr kumimoji="1" lang="zh-CN" altLang="en-US" smtClean="0"/>
              <a:t>2025/11/3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D2B7635-67F9-7A69-757D-B90D33DC8E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4D6BBC4-A23E-095C-A2F6-96B5463507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1DF9A-5983-EE41-B6BA-93DBFD97DF6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625397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AAA5147-E3DF-BEDF-A6C3-497DBFBA61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140DE44-4B80-4F89-A38B-8E5CFAECEB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3E298B1-397D-F446-6AEF-3DCEC4D379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02B8A75-A23D-FDD1-3B3F-0B88A4DF69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9485370-A27D-7D79-2DCB-F8602D484B8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A8024DE-6C81-EEAE-2FE5-7C9333AEE3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165C6-C8CD-4048-8DF5-28BD54BD31AA}" type="datetimeFigureOut">
              <a:rPr kumimoji="1" lang="zh-CN" altLang="en-US" smtClean="0"/>
              <a:t>2025/11/3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9BC7F81-6FA3-CC40-BB37-F14DFC22E7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76FBE1A3-9975-0898-89B5-DB566A1BFF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1DF9A-5983-EE41-B6BA-93DBFD97DF6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83257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CEE660-1810-110A-1D7D-BDAF916B6F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06EC305-F3C7-DAE8-E905-BF070D0F6A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165C6-C8CD-4048-8DF5-28BD54BD31AA}" type="datetimeFigureOut">
              <a:rPr kumimoji="1" lang="zh-CN" altLang="en-US" smtClean="0"/>
              <a:t>2025/11/3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E74B9F9-E340-30F3-6621-D12C7D0B8C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ECCDD03-FA6A-5497-E576-9160B993BC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1DF9A-5983-EE41-B6BA-93DBFD97DF6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741178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A4C00FB-E4FA-DDC0-B236-FE4BBD91B8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165C6-C8CD-4048-8DF5-28BD54BD31AA}" type="datetimeFigureOut">
              <a:rPr kumimoji="1" lang="zh-CN" altLang="en-US" smtClean="0"/>
              <a:t>2025/11/3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DE01421-3711-4AB8-81D8-1C42BF03F3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82A5431-ECAB-152F-6A3E-22CCCD36D7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1DF9A-5983-EE41-B6BA-93DBFD97DF6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88946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BFF5F68-356D-4DD9-5A21-B58C25816E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E9B817B-9B52-097E-4B57-5D5108AB753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40E0095-3E8F-60B0-9CA6-122131D40D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AB4D928-7CB4-103C-C70F-1255436FE1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165C6-C8CD-4048-8DF5-28BD54BD31AA}" type="datetimeFigureOut">
              <a:rPr kumimoji="1" lang="zh-CN" altLang="en-US" smtClean="0"/>
              <a:t>2025/11/3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DF54D4D-726B-2DB5-4858-3305ED4657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85420F1-A9DA-243E-80BB-8D61D4BF78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1DF9A-5983-EE41-B6BA-93DBFD97DF6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941454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1330CE4-F738-CE96-E95F-45C8AFC8C0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F59E557-21DA-0734-6C9E-533EFC3E886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C44C155-2E55-C080-B455-0ADD82F84D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5DEE867-9A37-197D-877B-30452F080C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165C6-C8CD-4048-8DF5-28BD54BD31AA}" type="datetimeFigureOut">
              <a:rPr kumimoji="1" lang="zh-CN" altLang="en-US" smtClean="0"/>
              <a:t>2025/11/3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75ACCA8-88B4-F338-1507-621E55821E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4BDDC55-D043-519F-1889-A3F574C1E4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1DF9A-5983-EE41-B6BA-93DBFD97DF6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245602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B31EABD-2AD6-36E1-0493-F488106EA3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7F91233-1A08-4A7F-D00F-D9C13E0D7A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39E6FE4-E63B-F005-6BFC-E107DCF68E2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66165C6-C8CD-4048-8DF5-28BD54BD31AA}" type="datetimeFigureOut">
              <a:rPr kumimoji="1" lang="zh-CN" altLang="en-US" smtClean="0"/>
              <a:t>2025/11/3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B428D22-CA71-8A03-D4E6-B6783DBFB08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074EA5B-8CAB-367E-94C4-C71C3DCB02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551DF9A-5983-EE41-B6BA-93DBFD97DF6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084200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7" Type="http://schemas.openxmlformats.org/officeDocument/2006/relationships/image" Target="../media/image26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png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7" Type="http://schemas.openxmlformats.org/officeDocument/2006/relationships/image" Target="../media/image32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1.png"/><Relationship Id="rId5" Type="http://schemas.openxmlformats.org/officeDocument/2006/relationships/image" Target="../media/image30.png"/><Relationship Id="rId4" Type="http://schemas.openxmlformats.org/officeDocument/2006/relationships/image" Target="../media/image29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图片 24">
            <a:extLst>
              <a:ext uri="{FF2B5EF4-FFF2-40B4-BE49-F238E27FC236}">
                <a16:creationId xmlns:a16="http://schemas.microsoft.com/office/drawing/2014/main" id="{A9470941-A07F-6CE0-17C4-EE98A328AD7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99485" y="3647527"/>
            <a:ext cx="2695476" cy="1428517"/>
          </a:xfrm>
          <a:prstGeom prst="rect">
            <a:avLst/>
          </a:prstGeom>
        </p:spPr>
      </p:pic>
      <p:sp>
        <p:nvSpPr>
          <p:cNvPr id="2" name="标题 1">
            <a:extLst>
              <a:ext uri="{FF2B5EF4-FFF2-40B4-BE49-F238E27FC236}">
                <a16:creationId xmlns:a16="http://schemas.microsoft.com/office/drawing/2014/main" id="{CA762458-9F45-F950-83DA-A0E3C50BF6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18679"/>
            <a:ext cx="10515600" cy="1325563"/>
          </a:xfrm>
        </p:spPr>
        <p:txBody>
          <a:bodyPr/>
          <a:lstStyle/>
          <a:p>
            <a:r>
              <a:rPr kumimoji="1" lang="en-US" altLang="zh-CN" dirty="0"/>
              <a:t>Full unedited gel for Fig. 2A</a:t>
            </a:r>
            <a:endParaRPr kumimoji="1"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A0AE603F-95A6-5109-1DDB-02EC16D4F10F}"/>
              </a:ext>
            </a:extLst>
          </p:cNvPr>
          <p:cNvSpPr txBox="1"/>
          <p:nvPr/>
        </p:nvSpPr>
        <p:spPr>
          <a:xfrm>
            <a:off x="8791059" y="4454166"/>
            <a:ext cx="2323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GAPDH with marker</a:t>
            </a:r>
            <a:endParaRPr kumimoji="1"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2858D297-6F79-C951-4A0E-3A868E974160}"/>
              </a:ext>
            </a:extLst>
          </p:cNvPr>
          <p:cNvSpPr txBox="1"/>
          <p:nvPr/>
        </p:nvSpPr>
        <p:spPr>
          <a:xfrm>
            <a:off x="8503452" y="2155450"/>
            <a:ext cx="26900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FUOM with marker</a:t>
            </a:r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84ABA95B-912D-FD10-BDEF-F187C9E6B04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11589" y="1640265"/>
            <a:ext cx="2428358" cy="1690629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6E310494-F1D5-BBB0-3DD7-593C45441AB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11589" y="3653844"/>
            <a:ext cx="2592197" cy="1428517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603DB8D9-23D2-8C83-2BB5-415C3D50603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900183" y="1640267"/>
            <a:ext cx="2603269" cy="1690629"/>
          </a:xfrm>
          <a:prstGeom prst="rect">
            <a:avLst/>
          </a:prstGeom>
        </p:spPr>
      </p:pic>
      <p:sp>
        <p:nvSpPr>
          <p:cNvPr id="23" name="矩形 22">
            <a:extLst>
              <a:ext uri="{FF2B5EF4-FFF2-40B4-BE49-F238E27FC236}">
                <a16:creationId xmlns:a16="http://schemas.microsoft.com/office/drawing/2014/main" id="{CF9B554D-49B9-658A-E287-40D6D3F6E6F8}"/>
              </a:ext>
            </a:extLst>
          </p:cNvPr>
          <p:cNvSpPr/>
          <p:nvPr/>
        </p:nvSpPr>
        <p:spPr>
          <a:xfrm>
            <a:off x="2904565" y="2000922"/>
            <a:ext cx="5690795" cy="44106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0CAE903A-C260-5951-7760-C451F5453373}"/>
              </a:ext>
            </a:extLst>
          </p:cNvPr>
          <p:cNvSpPr/>
          <p:nvPr/>
        </p:nvSpPr>
        <p:spPr>
          <a:xfrm>
            <a:off x="2904565" y="4333219"/>
            <a:ext cx="5787879" cy="52614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761329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6E586C6-4BC1-867A-3D46-1560BB6356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1325563"/>
          </a:xfrm>
        </p:spPr>
        <p:txBody>
          <a:bodyPr/>
          <a:lstStyle/>
          <a:p>
            <a:r>
              <a:rPr kumimoji="1" lang="en-US" altLang="zh-CN" dirty="0"/>
              <a:t>Full unedited gel for Fig 2E</a:t>
            </a:r>
            <a:endParaRPr kumimoji="1"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6A8BA653-4A48-1F73-8867-E10A6BC4D9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60557" y="1030727"/>
            <a:ext cx="3023415" cy="2225154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55801864-ACDD-8892-213C-E51A511D4D2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40038" y="1005507"/>
            <a:ext cx="3570502" cy="2250374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78F6D4F7-58D2-BF2A-6DA7-02E32F0F80A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60557" y="3429000"/>
            <a:ext cx="3041657" cy="1605844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7266758F-C0D4-41E6-78AF-2F4BF70CC19A}"/>
              </a:ext>
            </a:extLst>
          </p:cNvPr>
          <p:cNvSpPr txBox="1"/>
          <p:nvPr/>
        </p:nvSpPr>
        <p:spPr>
          <a:xfrm>
            <a:off x="9048259" y="1660275"/>
            <a:ext cx="26900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FUOM with marker</a:t>
            </a: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2305E244-DA51-3479-AD91-539C27198F46}"/>
              </a:ext>
            </a:extLst>
          </p:cNvPr>
          <p:cNvSpPr/>
          <p:nvPr/>
        </p:nvSpPr>
        <p:spPr>
          <a:xfrm>
            <a:off x="1730520" y="1546578"/>
            <a:ext cx="7187702" cy="59672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AB7AF766-084E-A731-F517-9173E76653C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05416" y="4249504"/>
            <a:ext cx="3570502" cy="658170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EAB1C7B0-81F5-8E8D-F691-123EE7BF7B18}"/>
              </a:ext>
            </a:extLst>
          </p:cNvPr>
          <p:cNvSpPr/>
          <p:nvPr/>
        </p:nvSpPr>
        <p:spPr>
          <a:xfrm>
            <a:off x="1730520" y="4243214"/>
            <a:ext cx="7187702" cy="59672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CC8CD815-66A3-F47A-A693-4A76AE330597}"/>
              </a:ext>
            </a:extLst>
          </p:cNvPr>
          <p:cNvSpPr txBox="1"/>
          <p:nvPr/>
        </p:nvSpPr>
        <p:spPr>
          <a:xfrm>
            <a:off x="9048259" y="4356911"/>
            <a:ext cx="2323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GAPDH with marker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1451783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图片 15">
            <a:extLst>
              <a:ext uri="{FF2B5EF4-FFF2-40B4-BE49-F238E27FC236}">
                <a16:creationId xmlns:a16="http://schemas.microsoft.com/office/drawing/2014/main" id="{14AE27EB-E61C-6014-617F-A6885AEFDB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1192" y="3777342"/>
            <a:ext cx="3814610" cy="120218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DBB84BE2-1CE0-290E-F5AF-990317794C8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5754" y="1881745"/>
            <a:ext cx="3847027" cy="170180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183C66E8-B188-2105-0674-2417151E53B5}"/>
              </a:ext>
            </a:extLst>
          </p:cNvPr>
          <p:cNvSpPr txBox="1"/>
          <p:nvPr/>
        </p:nvSpPr>
        <p:spPr>
          <a:xfrm>
            <a:off x="8839453" y="2918441"/>
            <a:ext cx="26900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FUOM with marker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A015D97B-2CA5-329B-CBE3-61CE07F467E4}"/>
              </a:ext>
            </a:extLst>
          </p:cNvPr>
          <p:cNvSpPr txBox="1"/>
          <p:nvPr/>
        </p:nvSpPr>
        <p:spPr>
          <a:xfrm>
            <a:off x="9314121" y="4432256"/>
            <a:ext cx="22153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GAPDH</a:t>
            </a:r>
            <a:r>
              <a:rPr kumimoji="1" lang="zh-CN" altLang="en-US" dirty="0"/>
              <a:t> </a:t>
            </a:r>
            <a:r>
              <a:rPr kumimoji="1" lang="en-US" altLang="zh-CN" dirty="0"/>
              <a:t>with marker</a:t>
            </a:r>
            <a:endParaRPr kumimoji="1" lang="zh-CN" altLang="en-US" dirty="0"/>
          </a:p>
        </p:txBody>
      </p:sp>
      <p:sp>
        <p:nvSpPr>
          <p:cNvPr id="10" name="标题 1">
            <a:extLst>
              <a:ext uri="{FF2B5EF4-FFF2-40B4-BE49-F238E27FC236}">
                <a16:creationId xmlns:a16="http://schemas.microsoft.com/office/drawing/2014/main" id="{995016D1-59F6-6041-CEBE-D669407BFB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1325563"/>
          </a:xfrm>
        </p:spPr>
        <p:txBody>
          <a:bodyPr/>
          <a:lstStyle/>
          <a:p>
            <a:r>
              <a:rPr kumimoji="1" lang="en-US" altLang="zh-CN" dirty="0"/>
              <a:t>Full unedited gel for Fig 2G</a:t>
            </a:r>
            <a:endParaRPr kumimoji="1" lang="zh-CN" altLang="en-US" dirty="0"/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2CAE368C-DCE0-6903-B272-3239F6D13DF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43967" y="3748386"/>
            <a:ext cx="4183944" cy="133350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C96E4E58-66AC-468F-5A5B-F8AE2DF537C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43967" y="1691245"/>
            <a:ext cx="3924300" cy="1892300"/>
          </a:xfrm>
          <a:prstGeom prst="rect">
            <a:avLst/>
          </a:prstGeom>
        </p:spPr>
      </p:pic>
      <p:sp>
        <p:nvSpPr>
          <p:cNvPr id="14" name="矩形 13">
            <a:extLst>
              <a:ext uri="{FF2B5EF4-FFF2-40B4-BE49-F238E27FC236}">
                <a16:creationId xmlns:a16="http://schemas.microsoft.com/office/drawing/2014/main" id="{8B3F1279-7916-4330-746E-D6EFC4A21366}"/>
              </a:ext>
            </a:extLst>
          </p:cNvPr>
          <p:cNvSpPr/>
          <p:nvPr/>
        </p:nvSpPr>
        <p:spPr>
          <a:xfrm>
            <a:off x="398430" y="2804744"/>
            <a:ext cx="8282725" cy="59672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98347250-CC52-1067-D0C9-2462AF52BD04}"/>
              </a:ext>
            </a:extLst>
          </p:cNvPr>
          <p:cNvSpPr/>
          <p:nvPr/>
        </p:nvSpPr>
        <p:spPr>
          <a:xfrm>
            <a:off x="398429" y="4041422"/>
            <a:ext cx="8587527" cy="87386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779992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标题 7">
            <a:extLst>
              <a:ext uri="{FF2B5EF4-FFF2-40B4-BE49-F238E27FC236}">
                <a16:creationId xmlns:a16="http://schemas.microsoft.com/office/drawing/2014/main" id="{030097B0-020D-2D9B-B27F-F6468C899F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1325563"/>
          </a:xfrm>
        </p:spPr>
        <p:txBody>
          <a:bodyPr/>
          <a:lstStyle/>
          <a:p>
            <a:r>
              <a:rPr kumimoji="1" lang="en-US" altLang="zh-CN" dirty="0"/>
              <a:t>Full unedited gel for </a:t>
            </a:r>
            <a:r>
              <a:rPr lang="en-US" altLang="zh-CN" dirty="0"/>
              <a:t>Fig 2I</a:t>
            </a:r>
            <a:endParaRPr lang="zh-CN" altLang="en-US" dirty="0"/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5D131CF9-3418-7880-91B5-F9B3A3161E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55989" y="2166761"/>
            <a:ext cx="4241800" cy="128270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FD32CB92-D15E-3168-EA62-ABCF4C30E31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0800000">
            <a:off x="2873022" y="3642958"/>
            <a:ext cx="3759200" cy="1130300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3571CF2C-1F37-94EB-2C53-FE3238010B7A}"/>
              </a:ext>
            </a:extLst>
          </p:cNvPr>
          <p:cNvSpPr txBox="1"/>
          <p:nvPr/>
        </p:nvSpPr>
        <p:spPr>
          <a:xfrm>
            <a:off x="6654800" y="2395549"/>
            <a:ext cx="20943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FUOM with marker</a:t>
            </a: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FF515725-DF72-0279-60D7-AC7C6343BEB1}"/>
              </a:ext>
            </a:extLst>
          </p:cNvPr>
          <p:cNvSpPr/>
          <p:nvPr/>
        </p:nvSpPr>
        <p:spPr>
          <a:xfrm>
            <a:off x="1911146" y="2314221"/>
            <a:ext cx="4625122" cy="44926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8E719FCB-2649-A267-14D6-09DB48EDBEAE}"/>
              </a:ext>
            </a:extLst>
          </p:cNvPr>
          <p:cNvSpPr/>
          <p:nvPr/>
        </p:nvSpPr>
        <p:spPr>
          <a:xfrm>
            <a:off x="2873021" y="4093120"/>
            <a:ext cx="3663247" cy="426327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67581465-2D5E-92D7-001B-62704D0967A4}"/>
              </a:ext>
            </a:extLst>
          </p:cNvPr>
          <p:cNvSpPr txBox="1"/>
          <p:nvPr/>
        </p:nvSpPr>
        <p:spPr>
          <a:xfrm>
            <a:off x="6654800" y="4121617"/>
            <a:ext cx="2323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GAPDH with marker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235889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8142908-4DA2-84CB-2518-B6C43C4867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18320"/>
            <a:ext cx="10515600" cy="1325563"/>
          </a:xfrm>
        </p:spPr>
        <p:txBody>
          <a:bodyPr/>
          <a:lstStyle/>
          <a:p>
            <a:r>
              <a:rPr kumimoji="1" lang="en-US" altLang="zh-CN" dirty="0"/>
              <a:t>Full unedited gel for Fig 4D</a:t>
            </a:r>
            <a:endParaRPr kumimoji="1"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18F5D2EF-192C-15CE-0740-ABFED2CD22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8909" y="4453491"/>
            <a:ext cx="3716466" cy="1262196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BD1135E6-9495-AA82-DFCB-7B1879396C3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8909" y="1571272"/>
            <a:ext cx="3708400" cy="1262196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CB691113-0F70-5774-53FD-AA3D93CFE26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94194" y="1588955"/>
            <a:ext cx="4241800" cy="1244513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F10727B5-1AD1-5FAF-56DF-1D5EA39F290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8909" y="3145014"/>
            <a:ext cx="3708400" cy="996931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B24E1C41-EFB3-C124-033D-9C04ED894CF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94193" y="3145014"/>
            <a:ext cx="4919133" cy="10414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DB121FA1-4483-6B86-581A-0D140CDE1A6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354677" y="4761035"/>
            <a:ext cx="4249865" cy="977900"/>
          </a:xfrm>
          <a:prstGeom prst="rect">
            <a:avLst/>
          </a:prstGeom>
        </p:spPr>
      </p:pic>
      <p:sp>
        <p:nvSpPr>
          <p:cNvPr id="10" name="矩形 9">
            <a:extLst>
              <a:ext uri="{FF2B5EF4-FFF2-40B4-BE49-F238E27FC236}">
                <a16:creationId xmlns:a16="http://schemas.microsoft.com/office/drawing/2014/main" id="{17A927CA-837A-2B18-0A91-1519D2B3D48D}"/>
              </a:ext>
            </a:extLst>
          </p:cNvPr>
          <p:cNvSpPr/>
          <p:nvPr/>
        </p:nvSpPr>
        <p:spPr>
          <a:xfrm>
            <a:off x="71056" y="1955244"/>
            <a:ext cx="8824587" cy="55088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BF89ABA4-0302-A828-3956-4E1C2EAAD7C2}"/>
              </a:ext>
            </a:extLst>
          </p:cNvPr>
          <p:cNvSpPr txBox="1"/>
          <p:nvPr/>
        </p:nvSpPr>
        <p:spPr>
          <a:xfrm>
            <a:off x="8988250" y="2005604"/>
            <a:ext cx="2323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 err="1"/>
              <a:t>iNOS</a:t>
            </a:r>
            <a:r>
              <a:rPr kumimoji="1" lang="en-US" altLang="zh-CN" dirty="0"/>
              <a:t> with marker</a:t>
            </a:r>
            <a:endParaRPr kumimoji="1"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120584C2-52E8-E7BB-4715-EF221FE005AC}"/>
              </a:ext>
            </a:extLst>
          </p:cNvPr>
          <p:cNvSpPr txBox="1"/>
          <p:nvPr/>
        </p:nvSpPr>
        <p:spPr>
          <a:xfrm>
            <a:off x="9549875" y="3481048"/>
            <a:ext cx="2323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CD163 with marker</a:t>
            </a:r>
            <a:endParaRPr kumimoji="1" lang="zh-CN" altLang="en-US" dirty="0"/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3CB88FCC-2187-EA6C-D6EF-0BF0FA04F1E2}"/>
              </a:ext>
            </a:extLst>
          </p:cNvPr>
          <p:cNvSpPr/>
          <p:nvPr/>
        </p:nvSpPr>
        <p:spPr>
          <a:xfrm>
            <a:off x="163664" y="3178869"/>
            <a:ext cx="8382026" cy="55088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FC5DD77A-4C52-C4B4-3BB4-109CB49C1A22}"/>
              </a:ext>
            </a:extLst>
          </p:cNvPr>
          <p:cNvSpPr/>
          <p:nvPr/>
        </p:nvSpPr>
        <p:spPr>
          <a:xfrm>
            <a:off x="292336" y="4780826"/>
            <a:ext cx="8382026" cy="55088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EE3F2ADA-D7FD-B73D-AC69-43DC585739DF}"/>
              </a:ext>
            </a:extLst>
          </p:cNvPr>
          <p:cNvSpPr txBox="1"/>
          <p:nvPr/>
        </p:nvSpPr>
        <p:spPr>
          <a:xfrm>
            <a:off x="8988277" y="4825295"/>
            <a:ext cx="14590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GAPDH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67398734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>
            <a:extLst>
              <a:ext uri="{FF2B5EF4-FFF2-40B4-BE49-F238E27FC236}">
                <a16:creationId xmlns:a16="http://schemas.microsoft.com/office/drawing/2014/main" id="{4B81DD0A-8E3E-D3D1-5C57-3285526EE4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2111" y="31475"/>
            <a:ext cx="10515600" cy="1325563"/>
          </a:xfrm>
        </p:spPr>
        <p:txBody>
          <a:bodyPr/>
          <a:lstStyle/>
          <a:p>
            <a:r>
              <a:rPr kumimoji="1" lang="en-US" altLang="zh-CN" dirty="0"/>
              <a:t>Full unedited gel for Fig 4P</a:t>
            </a:r>
            <a:endParaRPr kumimoji="1" lang="zh-CN" altLang="en-US" dirty="0"/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953F24D9-0458-A33D-288F-8796878EE12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64289" y="4015385"/>
            <a:ext cx="2259483" cy="2296858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C67858E8-50A4-137C-0670-127858B6C8A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64289" y="1538812"/>
            <a:ext cx="2259483" cy="2294799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71F3EA55-16E0-0F97-9D7F-E93A7214408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45543" y="1538812"/>
            <a:ext cx="2259483" cy="2283778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A173CE40-E357-F7B0-599A-0C661B10E5E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45543" y="4004364"/>
            <a:ext cx="2259483" cy="2306312"/>
          </a:xfrm>
          <a:prstGeom prst="rect">
            <a:avLst/>
          </a:prstGeom>
        </p:spPr>
      </p:pic>
      <p:sp>
        <p:nvSpPr>
          <p:cNvPr id="17" name="矩形 16">
            <a:extLst>
              <a:ext uri="{FF2B5EF4-FFF2-40B4-BE49-F238E27FC236}">
                <a16:creationId xmlns:a16="http://schemas.microsoft.com/office/drawing/2014/main" id="{44C23F35-8A8D-B677-4438-0B317A91E0CA}"/>
              </a:ext>
            </a:extLst>
          </p:cNvPr>
          <p:cNvSpPr/>
          <p:nvPr/>
        </p:nvSpPr>
        <p:spPr>
          <a:xfrm>
            <a:off x="1391120" y="3225864"/>
            <a:ext cx="5091321" cy="59672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97666D53-8DAB-1711-BC3B-BE6D69A4EB9A}"/>
              </a:ext>
            </a:extLst>
          </p:cNvPr>
          <p:cNvSpPr/>
          <p:nvPr/>
        </p:nvSpPr>
        <p:spPr>
          <a:xfrm>
            <a:off x="1358633" y="5691416"/>
            <a:ext cx="5091321" cy="59672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1DA13115-900F-64BA-6EFC-504881ECC236}"/>
              </a:ext>
            </a:extLst>
          </p:cNvPr>
          <p:cNvSpPr txBox="1"/>
          <p:nvPr/>
        </p:nvSpPr>
        <p:spPr>
          <a:xfrm>
            <a:off x="6600167" y="3319629"/>
            <a:ext cx="2323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FUOM with marker</a:t>
            </a:r>
            <a:endParaRPr kumimoji="1"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41F17B54-C42F-5300-8A0D-B90E2A7B8A67}"/>
              </a:ext>
            </a:extLst>
          </p:cNvPr>
          <p:cNvSpPr txBox="1"/>
          <p:nvPr/>
        </p:nvSpPr>
        <p:spPr>
          <a:xfrm>
            <a:off x="6600167" y="5805113"/>
            <a:ext cx="2323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CXCL13 with marker</a:t>
            </a:r>
            <a:endParaRPr kumimoji="1" lang="zh-CN" altLang="en-US" dirty="0"/>
          </a:p>
        </p:txBody>
      </p:sp>
      <p:pic>
        <p:nvPicPr>
          <p:cNvPr id="22" name="图片 21">
            <a:extLst>
              <a:ext uri="{FF2B5EF4-FFF2-40B4-BE49-F238E27FC236}">
                <a16:creationId xmlns:a16="http://schemas.microsoft.com/office/drawing/2014/main" id="{DE01E9EF-690C-72C9-1CC9-F0ECD5E430B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923384" y="1538812"/>
            <a:ext cx="2259482" cy="2294799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D33C54C1-ED24-A0AB-0EFE-196A3E52487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923552" y="4018301"/>
            <a:ext cx="2259314" cy="2269842"/>
          </a:xfrm>
          <a:prstGeom prst="rect">
            <a:avLst/>
          </a:prstGeom>
        </p:spPr>
      </p:pic>
      <p:sp>
        <p:nvSpPr>
          <p:cNvPr id="25" name="矩形 24">
            <a:extLst>
              <a:ext uri="{FF2B5EF4-FFF2-40B4-BE49-F238E27FC236}">
                <a16:creationId xmlns:a16="http://schemas.microsoft.com/office/drawing/2014/main" id="{3CFC902C-2879-433A-AE8E-2C5EA228458D}"/>
              </a:ext>
            </a:extLst>
          </p:cNvPr>
          <p:cNvSpPr/>
          <p:nvPr/>
        </p:nvSpPr>
        <p:spPr>
          <a:xfrm>
            <a:off x="8923383" y="5713950"/>
            <a:ext cx="2420120" cy="59672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9C01B6C8-5447-08FF-DB5B-56CB1EED5474}"/>
              </a:ext>
            </a:extLst>
          </p:cNvPr>
          <p:cNvSpPr/>
          <p:nvPr/>
        </p:nvSpPr>
        <p:spPr>
          <a:xfrm>
            <a:off x="8843065" y="3282712"/>
            <a:ext cx="2420120" cy="59672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0811921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CD672EC-C093-38E2-F90F-DD6DAE40E5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18255"/>
            <a:ext cx="10515600" cy="1325563"/>
          </a:xfrm>
        </p:spPr>
        <p:txBody>
          <a:bodyPr/>
          <a:lstStyle/>
          <a:p>
            <a:r>
              <a:rPr kumimoji="1" lang="en-US" altLang="zh-CN" dirty="0"/>
              <a:t>Full unedited gel for Fig 5D</a:t>
            </a:r>
            <a:endParaRPr kumimoji="1"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CB1F76C6-A94E-20FC-70D1-1926DE94B0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11034" y="2974976"/>
            <a:ext cx="1651000" cy="10414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90B3F64F-535D-3B87-86FF-45E1BC2405E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09545" y="2990850"/>
            <a:ext cx="1828800" cy="1057275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6FF6675F-253A-AC92-1101-2C547903618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88456" y="1343818"/>
            <a:ext cx="1676400" cy="120650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FC5504E5-1919-7BD5-33ED-FCFDB062B50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810955" y="1343818"/>
            <a:ext cx="1676400" cy="1219200"/>
          </a:xfrm>
          <a:prstGeom prst="rect">
            <a:avLst/>
          </a:prstGeom>
        </p:spPr>
      </p:pic>
      <p:sp>
        <p:nvSpPr>
          <p:cNvPr id="9" name="矩形 8">
            <a:extLst>
              <a:ext uri="{FF2B5EF4-FFF2-40B4-BE49-F238E27FC236}">
                <a16:creationId xmlns:a16="http://schemas.microsoft.com/office/drawing/2014/main" id="{562F1A2B-564F-CB35-843D-CDA335316BEA}"/>
              </a:ext>
            </a:extLst>
          </p:cNvPr>
          <p:cNvSpPr/>
          <p:nvPr/>
        </p:nvSpPr>
        <p:spPr>
          <a:xfrm>
            <a:off x="3496984" y="1926339"/>
            <a:ext cx="4141361" cy="44926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898B519C-C775-EF61-ED98-D1262EEB5E24}"/>
              </a:ext>
            </a:extLst>
          </p:cNvPr>
          <p:cNvSpPr/>
          <p:nvPr/>
        </p:nvSpPr>
        <p:spPr>
          <a:xfrm>
            <a:off x="3496984" y="3407391"/>
            <a:ext cx="4281060" cy="44926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5C249CE1-C3C2-E9A3-3B21-26C1D014697F}"/>
              </a:ext>
            </a:extLst>
          </p:cNvPr>
          <p:cNvSpPr txBox="1"/>
          <p:nvPr/>
        </p:nvSpPr>
        <p:spPr>
          <a:xfrm>
            <a:off x="7892094" y="4920821"/>
            <a:ext cx="2323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GAPDH with marker</a:t>
            </a:r>
            <a:endParaRPr kumimoji="1"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AC95F3CA-0944-410F-56F0-B34CC3460B05}"/>
              </a:ext>
            </a:extLst>
          </p:cNvPr>
          <p:cNvSpPr txBox="1"/>
          <p:nvPr/>
        </p:nvSpPr>
        <p:spPr>
          <a:xfrm>
            <a:off x="7892094" y="3447357"/>
            <a:ext cx="2323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CD163 with marker</a:t>
            </a:r>
            <a:endParaRPr kumimoji="1"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10834D4D-502B-5F60-72D0-77A046E05004}"/>
              </a:ext>
            </a:extLst>
          </p:cNvPr>
          <p:cNvSpPr txBox="1"/>
          <p:nvPr/>
        </p:nvSpPr>
        <p:spPr>
          <a:xfrm>
            <a:off x="7839869" y="2006272"/>
            <a:ext cx="2323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 err="1"/>
              <a:t>iNOS</a:t>
            </a:r>
            <a:r>
              <a:rPr kumimoji="1" lang="en-US" altLang="zh-CN" dirty="0"/>
              <a:t> with marker</a:t>
            </a:r>
            <a:endParaRPr kumimoji="1" lang="zh-CN" altLang="en-US" dirty="0"/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B1C986F4-537E-908A-6F26-8A5C77BC496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49461" y="4802531"/>
            <a:ext cx="1954389" cy="705752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CDDD155D-000C-6FEA-73E4-191F65C92AD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860345" y="4710907"/>
            <a:ext cx="1727200" cy="889000"/>
          </a:xfrm>
          <a:prstGeom prst="rect">
            <a:avLst/>
          </a:prstGeom>
        </p:spPr>
      </p:pic>
      <p:sp>
        <p:nvSpPr>
          <p:cNvPr id="16" name="矩形 15">
            <a:extLst>
              <a:ext uri="{FF2B5EF4-FFF2-40B4-BE49-F238E27FC236}">
                <a16:creationId xmlns:a16="http://schemas.microsoft.com/office/drawing/2014/main" id="{D1677564-FAF5-9324-FB59-5E7F7C699E55}"/>
              </a:ext>
            </a:extLst>
          </p:cNvPr>
          <p:cNvSpPr/>
          <p:nvPr/>
        </p:nvSpPr>
        <p:spPr>
          <a:xfrm>
            <a:off x="3330598" y="4920821"/>
            <a:ext cx="4447445" cy="44926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125594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5FA53EB-D2CA-52BF-F9B9-5D6B7C7A09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2111" y="31475"/>
            <a:ext cx="10515600" cy="1325563"/>
          </a:xfrm>
        </p:spPr>
        <p:txBody>
          <a:bodyPr/>
          <a:lstStyle/>
          <a:p>
            <a:r>
              <a:rPr kumimoji="1" lang="en-US" altLang="zh-CN" dirty="0"/>
              <a:t>Full unedited gel for Fig 5I</a:t>
            </a:r>
            <a:endParaRPr kumimoji="1"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ECD91020-E0B4-0667-5646-0A7996706E6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08439" y="3021972"/>
            <a:ext cx="5953198" cy="1325563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020D0F13-B528-B49E-4D13-90E7B29B728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00438" y="1229508"/>
            <a:ext cx="5880806" cy="1639281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3492989F-7BDA-0099-6191-C56DF268758E}"/>
              </a:ext>
            </a:extLst>
          </p:cNvPr>
          <p:cNvSpPr/>
          <p:nvPr/>
        </p:nvSpPr>
        <p:spPr>
          <a:xfrm>
            <a:off x="1877275" y="1843871"/>
            <a:ext cx="6341036" cy="53808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4A57BFAA-1816-B4C9-A474-3A44FFFF77BC}"/>
              </a:ext>
            </a:extLst>
          </p:cNvPr>
          <p:cNvSpPr txBox="1"/>
          <p:nvPr/>
        </p:nvSpPr>
        <p:spPr>
          <a:xfrm>
            <a:off x="8433387" y="1928247"/>
            <a:ext cx="20943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CD163 with marker</a:t>
            </a: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8D75BF67-BEA9-0B19-1476-1CB7BE50DE36}"/>
              </a:ext>
            </a:extLst>
          </p:cNvPr>
          <p:cNvSpPr/>
          <p:nvPr/>
        </p:nvSpPr>
        <p:spPr>
          <a:xfrm>
            <a:off x="2414520" y="3146668"/>
            <a:ext cx="6341036" cy="53808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30002EE1-04A6-5E26-0E11-95228272786F}"/>
              </a:ext>
            </a:extLst>
          </p:cNvPr>
          <p:cNvSpPr txBox="1"/>
          <p:nvPr/>
        </p:nvSpPr>
        <p:spPr>
          <a:xfrm>
            <a:off x="8755556" y="3231044"/>
            <a:ext cx="27026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CXCL13 with marker</a:t>
            </a: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4B41C976-3B4D-C841-00C5-823DDA845E0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08439" y="4593969"/>
            <a:ext cx="5953198" cy="1034524"/>
          </a:xfrm>
          <a:prstGeom prst="rect">
            <a:avLst/>
          </a:prstGeom>
        </p:spPr>
      </p:pic>
      <p:sp>
        <p:nvSpPr>
          <p:cNvPr id="12" name="矩形 11">
            <a:extLst>
              <a:ext uri="{FF2B5EF4-FFF2-40B4-BE49-F238E27FC236}">
                <a16:creationId xmlns:a16="http://schemas.microsoft.com/office/drawing/2014/main" id="{53A350F5-15A2-DBAB-EA1D-78679BC97FAA}"/>
              </a:ext>
            </a:extLst>
          </p:cNvPr>
          <p:cNvSpPr/>
          <p:nvPr/>
        </p:nvSpPr>
        <p:spPr>
          <a:xfrm>
            <a:off x="2437098" y="4737271"/>
            <a:ext cx="6341036" cy="53808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375C882A-DCB1-9FB4-2B68-21532A1C1126}"/>
              </a:ext>
            </a:extLst>
          </p:cNvPr>
          <p:cNvSpPr txBox="1"/>
          <p:nvPr/>
        </p:nvSpPr>
        <p:spPr>
          <a:xfrm>
            <a:off x="8945281" y="4821647"/>
            <a:ext cx="2323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GAPDH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725374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2</TotalTime>
  <Words>102</Words>
  <Application>Microsoft Office PowerPoint</Application>
  <PresentationFormat>宽屏</PresentationFormat>
  <Paragraphs>27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2" baseType="lpstr">
      <vt:lpstr>等线</vt:lpstr>
      <vt:lpstr>等线 Light</vt:lpstr>
      <vt:lpstr>Arial</vt:lpstr>
      <vt:lpstr>Office 主题​​</vt:lpstr>
      <vt:lpstr>Full unedited gel for Fig. 2A</vt:lpstr>
      <vt:lpstr>Full unedited gel for Fig 2E</vt:lpstr>
      <vt:lpstr>Full unedited gel for Fig 2G</vt:lpstr>
      <vt:lpstr>Full unedited gel for Fig 2I</vt:lpstr>
      <vt:lpstr>Full unedited gel for Fig 4D</vt:lpstr>
      <vt:lpstr>Full unedited gel for Fig 4P</vt:lpstr>
      <vt:lpstr>Full unedited gel for Fig 5D</vt:lpstr>
      <vt:lpstr>Full unedited gel for Fig 5I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ing lu</dc:creator>
  <cp:lastModifiedBy>bing lu</cp:lastModifiedBy>
  <cp:revision>29</cp:revision>
  <dcterms:created xsi:type="dcterms:W3CDTF">2024-12-12T05:05:26Z</dcterms:created>
  <dcterms:modified xsi:type="dcterms:W3CDTF">2025-11-03T05:15:59Z</dcterms:modified>
</cp:coreProperties>
</file>